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112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wen.Mullins\AppData\Local\Microsoft\Windows\Temporary%20Internet%20Files\Content.Outlook\R9IWM3PA\DRAFT(NEMATODE-PAPER)EWEN-FEBRUARY(F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0601006997537301E-2"/>
          <c:y val="5.4171014440850464E-2"/>
          <c:w val="0.70495810528221181"/>
          <c:h val="0.74960520057698821"/>
        </c:manualLayout>
      </c:layout>
      <c:lineChart>
        <c:grouping val="standard"/>
        <c:varyColors val="0"/>
        <c:ser>
          <c:idx val="0"/>
          <c:order val="0"/>
          <c:tx>
            <c:strRef>
              <c:f>'[DRAFT(NEMATODE-PAPER)EWEN-FEBRUARY(F).xlsx]Sheet3'!$E$2</c:f>
              <c:strCache>
                <c:ptCount val="1"/>
                <c:pt idx="0">
                  <c:v>H index</c:v>
                </c:pt>
              </c:strCache>
            </c:strRef>
          </c:tx>
          <c:marker>
            <c:symbol val="none"/>
          </c:marker>
          <c:cat>
            <c:strRef>
              <c:f>'[DRAFT(NEMATODE-PAPER)EWEN-FEBRUARY(F).xlsx]Sheet3'!$D$3:$D$8</c:f>
              <c:strCache>
                <c:ptCount val="6"/>
                <c:pt idx="0">
                  <c:v>Desiree control</c:v>
                </c:pt>
                <c:pt idx="1">
                  <c:v>Desiree chemical</c:v>
                </c:pt>
                <c:pt idx="2">
                  <c:v>Cisgenic Desiree control</c:v>
                </c:pt>
                <c:pt idx="3">
                  <c:v>Cisgenic Desiree chemical</c:v>
                </c:pt>
                <c:pt idx="4">
                  <c:v>Sarpo Mira control</c:v>
                </c:pt>
                <c:pt idx="5">
                  <c:v>Sarpo Mira chemical</c:v>
                </c:pt>
              </c:strCache>
            </c:strRef>
          </c:cat>
          <c:val>
            <c:numRef>
              <c:f>'[DRAFT(NEMATODE-PAPER)EWEN-FEBRUARY(F).xlsx]Sheet3'!$E$3:$E$8</c:f>
              <c:numCache>
                <c:formatCode>General</c:formatCode>
                <c:ptCount val="6"/>
                <c:pt idx="0">
                  <c:v>2.5</c:v>
                </c:pt>
                <c:pt idx="1">
                  <c:v>2.36</c:v>
                </c:pt>
                <c:pt idx="2">
                  <c:v>2.36</c:v>
                </c:pt>
                <c:pt idx="3">
                  <c:v>2.2400000000000002</c:v>
                </c:pt>
                <c:pt idx="4">
                  <c:v>2.42</c:v>
                </c:pt>
                <c:pt idx="5">
                  <c:v>2.3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AF0-4810-8F77-124B712CBCC8}"/>
            </c:ext>
          </c:extLst>
        </c:ser>
        <c:ser>
          <c:idx val="1"/>
          <c:order val="1"/>
          <c:tx>
            <c:strRef>
              <c:f>'[DRAFT(NEMATODE-PAPER)EWEN-FEBRUARY(F).xlsx]Sheet3'!$F$2</c:f>
              <c:strCache>
                <c:ptCount val="1"/>
                <c:pt idx="0">
                  <c:v>EH index</c:v>
                </c:pt>
              </c:strCache>
            </c:strRef>
          </c:tx>
          <c:marker>
            <c:symbol val="none"/>
          </c:marker>
          <c:cat>
            <c:strRef>
              <c:f>'[DRAFT(NEMATODE-PAPER)EWEN-FEBRUARY(F).xlsx]Sheet3'!$D$3:$D$8</c:f>
              <c:strCache>
                <c:ptCount val="6"/>
                <c:pt idx="0">
                  <c:v>Desiree control</c:v>
                </c:pt>
                <c:pt idx="1">
                  <c:v>Desiree chemical</c:v>
                </c:pt>
                <c:pt idx="2">
                  <c:v>Cisgenic Desiree control</c:v>
                </c:pt>
                <c:pt idx="3">
                  <c:v>Cisgenic Desiree chemical</c:v>
                </c:pt>
                <c:pt idx="4">
                  <c:v>Sarpo Mira control</c:v>
                </c:pt>
                <c:pt idx="5">
                  <c:v>Sarpo Mira chemical</c:v>
                </c:pt>
              </c:strCache>
            </c:strRef>
          </c:cat>
          <c:val>
            <c:numRef>
              <c:f>'[DRAFT(NEMATODE-PAPER)EWEN-FEBRUARY(F).xlsx]Sheet3'!$F$3:$F$8</c:f>
              <c:numCache>
                <c:formatCode>General</c:formatCode>
                <c:ptCount val="6"/>
                <c:pt idx="0">
                  <c:v>0.66</c:v>
                </c:pt>
                <c:pt idx="1">
                  <c:v>0.62</c:v>
                </c:pt>
                <c:pt idx="2">
                  <c:v>0.63</c:v>
                </c:pt>
                <c:pt idx="3">
                  <c:v>0.59</c:v>
                </c:pt>
                <c:pt idx="4">
                  <c:v>0.63</c:v>
                </c:pt>
                <c:pt idx="5">
                  <c:v>0.6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0AF0-4810-8F77-124B712CBC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631488"/>
        <c:axId val="41898368"/>
      </c:lineChart>
      <c:catAx>
        <c:axId val="396314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1898368"/>
        <c:crosses val="autoZero"/>
        <c:auto val="1"/>
        <c:lblAlgn val="ctr"/>
        <c:lblOffset val="100"/>
        <c:noMultiLvlLbl val="0"/>
      </c:catAx>
      <c:valAx>
        <c:axId val="4189836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3963148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10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501A2-8173-4933-889D-4C3D4F2570FA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7A3D4-EF2A-4AF4-B8D3-E65C7BAF68F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072193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501A2-8173-4933-889D-4C3D4F2570FA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7A3D4-EF2A-4AF4-B8D3-E65C7BAF68F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415895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501A2-8173-4933-889D-4C3D4F2570FA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7A3D4-EF2A-4AF4-B8D3-E65C7BAF68F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099048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501A2-8173-4933-889D-4C3D4F2570FA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7A3D4-EF2A-4AF4-B8D3-E65C7BAF68F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77107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501A2-8173-4933-889D-4C3D4F2570FA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7A3D4-EF2A-4AF4-B8D3-E65C7BAF68F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981198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501A2-8173-4933-889D-4C3D4F2570FA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7A3D4-EF2A-4AF4-B8D3-E65C7BAF68F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949784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501A2-8173-4933-889D-4C3D4F2570FA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7A3D4-EF2A-4AF4-B8D3-E65C7BAF68F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90456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501A2-8173-4933-889D-4C3D4F2570FA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7A3D4-EF2A-4AF4-B8D3-E65C7BAF68F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116180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501A2-8173-4933-889D-4C3D4F2570FA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7A3D4-EF2A-4AF4-B8D3-E65C7BAF68F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139901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501A2-8173-4933-889D-4C3D4F2570FA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7A3D4-EF2A-4AF4-B8D3-E65C7BAF68F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939541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501A2-8173-4933-889D-4C3D4F2570FA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97A3D4-EF2A-4AF4-B8D3-E65C7BAF68F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32511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F501A2-8173-4933-889D-4C3D4F2570FA}" type="datetimeFigureOut">
              <a:rPr lang="en-IE" smtClean="0"/>
              <a:t>17/11/20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7A3D4-EF2A-4AF4-B8D3-E65C7BAF68F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69497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3194016301"/>
              </p:ext>
            </p:extLst>
          </p:nvPr>
        </p:nvGraphicFramePr>
        <p:xfrm>
          <a:off x="1947862" y="1893252"/>
          <a:ext cx="5248275" cy="30714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/>
          <p:cNvSpPr/>
          <p:nvPr/>
        </p:nvSpPr>
        <p:spPr>
          <a:xfrm>
            <a:off x="1187624" y="188640"/>
            <a:ext cx="734481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E" sz="1200" b="1" dirty="0"/>
              <a:t>Figure S3. </a:t>
            </a:r>
            <a:r>
              <a:rPr lang="en-IE" sz="1200" dirty="0"/>
              <a:t>Uniformity of values across the Shannon Diversity (H) and Shannon Equitability (EH) indices for samples taken from under different potatoes genotypes (Desiree, </a:t>
            </a:r>
            <a:r>
              <a:rPr lang="en-IE" sz="1200" dirty="0" err="1"/>
              <a:t>cisgenic</a:t>
            </a:r>
            <a:r>
              <a:rPr lang="en-IE" sz="1200" dirty="0"/>
              <a:t> Desiree, </a:t>
            </a:r>
            <a:r>
              <a:rPr lang="en-IE" sz="1200" dirty="0" err="1"/>
              <a:t>Sarpo</a:t>
            </a:r>
            <a:r>
              <a:rPr lang="en-IE" sz="1200" dirty="0"/>
              <a:t> Mira) treated with different disease management regimes (control, chemical treatment) through the years of 2013, 2014 and 2015 at Oak Park (Carlow, Ireland).</a:t>
            </a:r>
          </a:p>
        </p:txBody>
      </p:sp>
    </p:spTree>
    <p:extLst>
      <p:ext uri="{BB962C8B-B14F-4D97-AF65-F5344CB8AC3E}">
        <p14:creationId xmlns:p14="http://schemas.microsoft.com/office/powerpoint/2010/main" val="315698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eaga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wen Mullins</dc:creator>
  <cp:lastModifiedBy>Ewen Mullins</cp:lastModifiedBy>
  <cp:revision>1</cp:revision>
  <dcterms:created xsi:type="dcterms:W3CDTF">2016-11-17T13:44:28Z</dcterms:created>
  <dcterms:modified xsi:type="dcterms:W3CDTF">2016-11-17T13:45:19Z</dcterms:modified>
</cp:coreProperties>
</file>